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24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102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BE6A3-37F7-493A-AAFE-D9BFCA876AB9}" type="datetimeFigureOut">
              <a:rPr lang="zh-CN" altLang="en-US" smtClean="0"/>
              <a:t>2021-5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CD36D-9042-49C4-8149-C9EB1B1C4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8199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BE6A3-37F7-493A-AAFE-D9BFCA876AB9}" type="datetimeFigureOut">
              <a:rPr lang="zh-CN" altLang="en-US" smtClean="0"/>
              <a:t>2021-5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CD36D-9042-49C4-8149-C9EB1B1C4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2751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BE6A3-37F7-493A-AAFE-D9BFCA876AB9}" type="datetimeFigureOut">
              <a:rPr lang="zh-CN" altLang="en-US" smtClean="0"/>
              <a:t>2021-5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CD36D-9042-49C4-8149-C9EB1B1C4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92788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BE6A3-37F7-493A-AAFE-D9BFCA876AB9}" type="datetimeFigureOut">
              <a:rPr lang="zh-CN" altLang="en-US" smtClean="0"/>
              <a:t>2021-5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CD36D-9042-49C4-8149-C9EB1B1C4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1598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BE6A3-37F7-493A-AAFE-D9BFCA876AB9}" type="datetimeFigureOut">
              <a:rPr lang="zh-CN" altLang="en-US" smtClean="0"/>
              <a:t>2021-5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CD36D-9042-49C4-8149-C9EB1B1C4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6101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BE6A3-37F7-493A-AAFE-D9BFCA876AB9}" type="datetimeFigureOut">
              <a:rPr lang="zh-CN" altLang="en-US" smtClean="0"/>
              <a:t>2021-5-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CD36D-9042-49C4-8149-C9EB1B1C4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2602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BE6A3-37F7-493A-AAFE-D9BFCA876AB9}" type="datetimeFigureOut">
              <a:rPr lang="zh-CN" altLang="en-US" smtClean="0"/>
              <a:t>2021-5-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CD36D-9042-49C4-8149-C9EB1B1C4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08358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BE6A3-37F7-493A-AAFE-D9BFCA876AB9}" type="datetimeFigureOut">
              <a:rPr lang="zh-CN" altLang="en-US" smtClean="0"/>
              <a:t>2021-5-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CD36D-9042-49C4-8149-C9EB1B1C4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1196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BE6A3-37F7-493A-AAFE-D9BFCA876AB9}" type="datetimeFigureOut">
              <a:rPr lang="zh-CN" altLang="en-US" smtClean="0"/>
              <a:t>2021-5-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CD36D-9042-49C4-8149-C9EB1B1C4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3880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BE6A3-37F7-493A-AAFE-D9BFCA876AB9}" type="datetimeFigureOut">
              <a:rPr lang="zh-CN" altLang="en-US" smtClean="0"/>
              <a:t>2021-5-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CD36D-9042-49C4-8149-C9EB1B1C4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7835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BE6A3-37F7-493A-AAFE-D9BFCA876AB9}" type="datetimeFigureOut">
              <a:rPr lang="zh-CN" altLang="en-US" smtClean="0"/>
              <a:t>2021-5-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DCD36D-9042-49C4-8149-C9EB1B1C4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331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DBE6A3-37F7-493A-AAFE-D9BFCA876AB9}" type="datetimeFigureOut">
              <a:rPr lang="zh-CN" altLang="en-US" smtClean="0"/>
              <a:t>2021-5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DCD36D-9042-49C4-8149-C9EB1B1C47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2249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f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f"/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f"/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tiff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tiff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502" y="689776"/>
            <a:ext cx="11562588" cy="2377440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188294" y="94905"/>
            <a:ext cx="262764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zf-MIZ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sp>
        <p:nvSpPr>
          <p:cNvPr id="6" name="矩形 5"/>
          <p:cNvSpPr/>
          <p:nvPr/>
        </p:nvSpPr>
        <p:spPr>
          <a:xfrm>
            <a:off x="179502" y="3257587"/>
            <a:ext cx="32704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zf-LITAF-like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854" y="3817290"/>
            <a:ext cx="11480292" cy="28072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053608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39217" y="103569"/>
            <a:ext cx="29145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fork head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6103" y="0"/>
            <a:ext cx="8695271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289360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16119" y="116821"/>
            <a:ext cx="22797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ETS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352" y="627656"/>
            <a:ext cx="11576304" cy="40919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428962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04942" y="169830"/>
            <a:ext cx="27799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ESR-like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942" y="676523"/>
            <a:ext cx="11576304" cy="2377440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204942" y="3311582"/>
            <a:ext cx="22717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E2F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954" y="3721674"/>
            <a:ext cx="11480292" cy="28072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920896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53470" y="143325"/>
            <a:ext cx="22862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DM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848" y="512657"/>
            <a:ext cx="11576304" cy="2807208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307848" y="3542415"/>
            <a:ext cx="25410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DACH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854" y="3989567"/>
            <a:ext cx="11480292" cy="2377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079495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04130" y="156577"/>
            <a:ext cx="23391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CUT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130" y="663272"/>
            <a:ext cx="11576304" cy="2377440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204130" y="3327544"/>
            <a:ext cx="22878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CSL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848" y="3830541"/>
            <a:ext cx="11576304" cy="2377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124643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62770" y="103569"/>
            <a:ext cx="23407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CSD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100" y="590749"/>
            <a:ext cx="11576304" cy="3151913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321100" y="3880438"/>
            <a:ext cx="23134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CP2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100" y="4249770"/>
            <a:ext cx="11576304" cy="24160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622243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56358" y="143326"/>
            <a:ext cx="23455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COE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848" y="636767"/>
            <a:ext cx="11576304" cy="2377440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207654" y="3226239"/>
            <a:ext cx="23054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CBF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654" y="3755866"/>
            <a:ext cx="11576304" cy="2377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731438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24759" y="169829"/>
            <a:ext cx="24994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bHLH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96" t="7821" r="6735" b="15000"/>
          <a:stretch/>
        </p:blipFill>
        <p:spPr>
          <a:xfrm>
            <a:off x="3332283" y="55925"/>
            <a:ext cx="5679832" cy="6802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596558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77306" y="116821"/>
            <a:ext cx="244009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ARID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100" y="717572"/>
            <a:ext cx="11576304" cy="45217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286505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17865" y="130073"/>
            <a:ext cx="242245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AF-4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865" y="663271"/>
            <a:ext cx="11576304" cy="2377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82941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361" y="760178"/>
            <a:ext cx="11576304" cy="409194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387361" y="169830"/>
            <a:ext cx="28087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zf-GATA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458077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99386" y="183082"/>
            <a:ext cx="28087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zf-CCCH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386" y="689775"/>
            <a:ext cx="11562588" cy="2377440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220224" y="3394540"/>
            <a:ext cx="27943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zf-C2HC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224" y="3923306"/>
            <a:ext cx="11576304" cy="2377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14236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97342" y="103569"/>
            <a:ext cx="27799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zf-C2H2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1403" y="0"/>
            <a:ext cx="4848386" cy="68580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43614" y="0"/>
            <a:ext cx="484838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86822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16786" y="130074"/>
            <a:ext cx="33858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Miscellaneous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786" y="663272"/>
            <a:ext cx="11480292" cy="2377440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116786" y="3329426"/>
            <a:ext cx="24192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MH1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126" y="3883549"/>
            <a:ext cx="11699748" cy="2377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74225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02602" y="156577"/>
            <a:ext cx="24256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MBD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845" y="597743"/>
            <a:ext cx="11480292" cy="3229093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302845" y="4052718"/>
            <a:ext cx="237436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HTH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865" y="4556301"/>
            <a:ext cx="11576304" cy="20962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04780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51495" y="130073"/>
            <a:ext cx="23182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HSF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593" y="689776"/>
            <a:ext cx="11480292" cy="2377440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151495" y="3298206"/>
            <a:ext cx="23775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HPD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593" y="3751028"/>
            <a:ext cx="11576304" cy="2377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6237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27932" y="116821"/>
            <a:ext cx="245131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HMG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5057" y="0"/>
            <a:ext cx="858776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207934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05962" y="143326"/>
            <a:ext cx="29851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GCNF-like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962" y="742785"/>
            <a:ext cx="11480292" cy="2377440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205962" y="3377596"/>
            <a:ext cx="24240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solidFill>
                  <a:srgbClr val="C00000"/>
                </a:solidFill>
              </a:rPr>
              <a:t>GCM-motif_locations</a:t>
            </a:r>
            <a:endParaRPr lang="zh-CN" altLang="en-US" b="1" dirty="0">
              <a:solidFill>
                <a:srgbClr val="C00000"/>
              </a:solidFill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856" y="3817289"/>
            <a:ext cx="11576304" cy="2377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5015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80</Words>
  <Application>Microsoft Office PowerPoint</Application>
  <PresentationFormat>宽屏</PresentationFormat>
  <Paragraphs>30</Paragraphs>
  <Slides>1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9</vt:i4>
      </vt:variant>
    </vt:vector>
  </HeadingPairs>
  <TitlesOfParts>
    <vt:vector size="23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马艳</dc:creator>
  <cp:lastModifiedBy>马艳</cp:lastModifiedBy>
  <cp:revision>3</cp:revision>
  <dcterms:created xsi:type="dcterms:W3CDTF">2021-05-02T14:36:28Z</dcterms:created>
  <dcterms:modified xsi:type="dcterms:W3CDTF">2021-05-02T14:54:38Z</dcterms:modified>
</cp:coreProperties>
</file>